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6" r:id="rId2"/>
  </p:sldIdLst>
  <p:sldSz cx="16200438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74"/>
    <p:restoredTop sz="96327"/>
  </p:normalViewPr>
  <p:slideViewPr>
    <p:cSldViewPr snapToGrid="0">
      <p:cViewPr varScale="1">
        <p:scale>
          <a:sx n="102" d="100"/>
          <a:sy n="102" d="100"/>
        </p:scale>
        <p:origin x="208" y="5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25055" y="1237197"/>
            <a:ext cx="12150329" cy="263188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3970580"/>
            <a:ext cx="12150329" cy="18251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3972" indent="0" algn="ctr">
              <a:buNone/>
              <a:defRPr sz="2205"/>
            </a:lvl2pPr>
            <a:lvl3pPr marL="1007943" indent="0" algn="ctr">
              <a:buNone/>
              <a:defRPr sz="1984"/>
            </a:lvl3pPr>
            <a:lvl4pPr marL="1511915" indent="0" algn="ctr">
              <a:buNone/>
              <a:defRPr sz="1764"/>
            </a:lvl4pPr>
            <a:lvl5pPr marL="2015886" indent="0" algn="ctr">
              <a:buNone/>
              <a:defRPr sz="1764"/>
            </a:lvl5pPr>
            <a:lvl6pPr marL="2519858" indent="0" algn="ctr">
              <a:buNone/>
              <a:defRPr sz="1764"/>
            </a:lvl6pPr>
            <a:lvl7pPr marL="3023829" indent="0" algn="ctr">
              <a:buNone/>
              <a:defRPr sz="1764"/>
            </a:lvl7pPr>
            <a:lvl8pPr marL="3527801" indent="0" algn="ctr">
              <a:buNone/>
              <a:defRPr sz="1764"/>
            </a:lvl8pPr>
            <a:lvl9pPr marL="4031772" indent="0" algn="ctr">
              <a:buNone/>
              <a:defRPr sz="176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338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839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39" y="402483"/>
            <a:ext cx="3493219" cy="64064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0" y="402483"/>
            <a:ext cx="10277153" cy="64064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690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332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2" y="1884670"/>
            <a:ext cx="13972878" cy="3144614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2" y="5059034"/>
            <a:ext cx="13972878" cy="165367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1pPr>
            <a:lvl2pPr marL="503972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7943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1915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58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1985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382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780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177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530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2012414"/>
            <a:ext cx="6885186" cy="47965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2012414"/>
            <a:ext cx="6885186" cy="47965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460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402483"/>
            <a:ext cx="13972878" cy="14611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1" y="1853171"/>
            <a:ext cx="6853544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1" y="2761381"/>
            <a:ext cx="6853544" cy="40615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2" y="1853171"/>
            <a:ext cx="6887296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2" y="2761381"/>
            <a:ext cx="6887296" cy="40615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85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704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177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1" y="503978"/>
            <a:ext cx="5225062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1088454"/>
            <a:ext cx="8201472" cy="5372269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1" y="2267902"/>
            <a:ext cx="5225062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111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1" y="503978"/>
            <a:ext cx="5225062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1088454"/>
            <a:ext cx="8201472" cy="5372269"/>
          </a:xfrm>
        </p:spPr>
        <p:txBody>
          <a:bodyPr anchor="t"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1" y="2267902"/>
            <a:ext cx="5225062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241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402483"/>
            <a:ext cx="13972878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2012414"/>
            <a:ext cx="13972878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7006699"/>
            <a:ext cx="3645099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F4588-C69F-454D-8AF8-A138E71CE0DF}" type="datetimeFigureOut">
              <a:rPr lang="en-US" smtClean="0"/>
              <a:t>4/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7006699"/>
            <a:ext cx="546764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7006699"/>
            <a:ext cx="3645099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20331D-ABCB-6243-A86A-48D4B144F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113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3D2DF4A-2144-64F4-6BB1-0F16E8FDA8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8705445" cy="652908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C2B9D1B-8FB0-906F-61B8-2CD52F9FA1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13579" y="40969"/>
            <a:ext cx="7406714" cy="339474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F7D4582-3C3D-73D8-C610-2FCE5DCE15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69190" y="3599108"/>
            <a:ext cx="3960567" cy="396056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DFC580B-1C08-A4B6-FD04-2D2F7E73EA4D}"/>
              </a:ext>
            </a:extLst>
          </p:cNvPr>
          <p:cNvSpPr txBox="1"/>
          <p:nvPr/>
        </p:nvSpPr>
        <p:spPr>
          <a:xfrm>
            <a:off x="0" y="0"/>
            <a:ext cx="14905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38D13E7-1FE8-3698-CD8A-8945BBDDCD95}"/>
              </a:ext>
            </a:extLst>
          </p:cNvPr>
          <p:cNvSpPr txBox="1"/>
          <p:nvPr/>
        </p:nvSpPr>
        <p:spPr>
          <a:xfrm>
            <a:off x="7960146" y="26815"/>
            <a:ext cx="14905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E90101-967B-A458-7DFC-FAB06E047C73}"/>
              </a:ext>
            </a:extLst>
          </p:cNvPr>
          <p:cNvSpPr txBox="1"/>
          <p:nvPr/>
        </p:nvSpPr>
        <p:spPr>
          <a:xfrm>
            <a:off x="8705445" y="3508827"/>
            <a:ext cx="14905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DE32365-D1B4-13B1-7132-14DECABFEBD9}"/>
              </a:ext>
            </a:extLst>
          </p:cNvPr>
          <p:cNvSpPr txBox="1"/>
          <p:nvPr/>
        </p:nvSpPr>
        <p:spPr>
          <a:xfrm>
            <a:off x="11864009" y="3532754"/>
            <a:ext cx="14905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9046E0B-350C-26EC-29E2-650203C3E5C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5922"/>
          <a:stretch/>
        </p:blipFill>
        <p:spPr>
          <a:xfrm>
            <a:off x="11906832" y="3890980"/>
            <a:ext cx="4293606" cy="329169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28217E6-37FF-9D5E-02E6-87520EE94D59}"/>
              </a:ext>
            </a:extLst>
          </p:cNvPr>
          <p:cNvSpPr txBox="1"/>
          <p:nvPr/>
        </p:nvSpPr>
        <p:spPr>
          <a:xfrm>
            <a:off x="12423777" y="7182679"/>
            <a:ext cx="263670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sts (ATP/time) controlled for codon redundanci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77682F2-0496-7811-BF63-7C31DC6C94CF}"/>
              </a:ext>
            </a:extLst>
          </p:cNvPr>
          <p:cNvSpPr txBox="1"/>
          <p:nvPr/>
        </p:nvSpPr>
        <p:spPr>
          <a:xfrm>
            <a:off x="0" y="6608050"/>
            <a:ext cx="851357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le 5.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) Differences in estimated amino acid frequency between our data and the RACCOON dataset. (b-c) The edge effect described here was also present in the RACCOON dataset. (d) The relationship between amino acid frequency and ATP/time costs from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43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GB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046101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</TotalTime>
  <Words>71</Words>
  <Application>Microsoft Macintosh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imoto, Juliano</dc:creator>
  <cp:lastModifiedBy>Morimoto, Juliano</cp:lastModifiedBy>
  <cp:revision>4</cp:revision>
  <dcterms:created xsi:type="dcterms:W3CDTF">2024-03-08T19:18:17Z</dcterms:created>
  <dcterms:modified xsi:type="dcterms:W3CDTF">2024-04-03T14:01:13Z</dcterms:modified>
</cp:coreProperties>
</file>